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png" ContentType="image/png"/>
  <Override PartName="/ppt/media/image5.wmf" ContentType="image/x-wmf"/>
  <Override PartName="/ppt/media/image6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6858000" cy="9907588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E20191-B3BB-4071-B1ED-ECD352EE3BD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6C966A-C959-4751-8E5E-5ED5BBB66C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619B7D-C375-44AD-898A-1710D08F61C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755719-6C5F-458B-A2BC-690D5470FEC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E995AA-6BA7-4B20-85D5-5D23D9604D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D422C1-0648-4BD1-9810-863807545F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8744B7-65EC-4E5C-86FE-E94BF2BE1A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215BD5-3B66-4256-BCCA-D5D913E9C6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E0FC86-790C-4D93-9AD5-313B5E10BC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F65B58-3912-4A09-A99D-582006575B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405D91-2CA3-43CB-A1D1-6BA8CE580D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48E2FC-72D0-4536-8C96-E1BCE32D46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6511CE-3744-40E0-B84C-C7128E6F207F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142560" y="130320"/>
            <a:ext cx="103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2" descr=""/>
          <p:cNvPicPr/>
          <p:nvPr/>
        </p:nvPicPr>
        <p:blipFill>
          <a:blip r:embed="rId1"/>
          <a:stretch/>
        </p:blipFill>
        <p:spPr>
          <a:xfrm>
            <a:off x="0" y="436680"/>
            <a:ext cx="3833640" cy="947880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43" name=""/>
          <p:cNvGraphicFramePr/>
          <p:nvPr/>
        </p:nvGraphicFramePr>
        <p:xfrm>
          <a:off x="3809880" y="9360"/>
          <a:ext cx="2938680" cy="9639360"/>
        </p:xfrm>
        <a:graphic>
          <a:graphicData uri="http://schemas.openxmlformats.org/drawingml/2006/table">
            <a:tbl>
              <a:tblPr/>
              <a:tblGrid>
                <a:gridCol w="366840"/>
                <a:gridCol w="382680"/>
                <a:gridCol w="352440"/>
                <a:gridCol w="366480"/>
                <a:gridCol w="465120"/>
                <a:gridCol w="270000"/>
                <a:gridCol w="366840"/>
                <a:gridCol w="368280"/>
              </a:tblGrid>
              <a:tr h="249480">
                <a:tc>
                  <a:txBody>
                    <a:bodyPr lIns="5760" rIns="5760" tIns="57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6">
                  <a:txBody>
                    <a:bodyPr lIns="5760" rIns="5760" tIns="57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luster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49120">
                <a:tc>
                  <a:txBody>
                    <a:bodyPr lIns="5760" rIns="5760" tIns="57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ut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1414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320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14112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4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68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120"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5760" rIns="5760" tIns="57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5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5760" marR="576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Box 1"/>
          <p:cNvSpPr/>
          <p:nvPr/>
        </p:nvSpPr>
        <p:spPr>
          <a:xfrm>
            <a:off x="332280" y="264960"/>
            <a:ext cx="103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5" name="Picture 5" descr=""/>
          <p:cNvPicPr/>
          <p:nvPr/>
        </p:nvPicPr>
        <p:blipFill>
          <a:blip r:embed="rId1"/>
          <a:stretch/>
        </p:blipFill>
        <p:spPr>
          <a:xfrm>
            <a:off x="0" y="955800"/>
            <a:ext cx="4568760" cy="569268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46" name=""/>
          <p:cNvGraphicFramePr/>
          <p:nvPr/>
        </p:nvGraphicFramePr>
        <p:xfrm>
          <a:off x="4564080" y="701640"/>
          <a:ext cx="2165400" cy="5608800"/>
        </p:xfrm>
        <a:graphic>
          <a:graphicData uri="http://schemas.openxmlformats.org/drawingml/2006/table">
            <a:tbl>
              <a:tblPr/>
              <a:tblGrid>
                <a:gridCol w="271440"/>
                <a:gridCol w="301680"/>
                <a:gridCol w="239760"/>
                <a:gridCol w="269640"/>
                <a:gridCol w="270000"/>
                <a:gridCol w="271440"/>
                <a:gridCol w="270000"/>
                <a:gridCol w="271440"/>
              </a:tblGrid>
              <a:tr h="193680">
                <a:tc>
                  <a:txBody>
                    <a:bodyPr lIns="10800" rIns="10800" tIns="108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6">
                  <a:txBody>
                    <a:bodyPr lIns="10800" rIns="10800" tIns="108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lust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93680">
                <a:tc>
                  <a:txBody>
                    <a:bodyPr lIns="10800" rIns="10800" tIns="108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u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40"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0800" rIns="10800" tIns="108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0800" marR="108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Box 1"/>
          <p:cNvSpPr/>
          <p:nvPr/>
        </p:nvSpPr>
        <p:spPr>
          <a:xfrm>
            <a:off x="350640" y="498600"/>
            <a:ext cx="103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0" y="2341440"/>
            <a:ext cx="5338800" cy="471960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49" name=""/>
          <p:cNvGraphicFramePr/>
          <p:nvPr/>
        </p:nvGraphicFramePr>
        <p:xfrm>
          <a:off x="5273640" y="1982880"/>
          <a:ext cx="1486080" cy="4670280"/>
        </p:xfrm>
        <a:graphic>
          <a:graphicData uri="http://schemas.openxmlformats.org/drawingml/2006/table">
            <a:tbl>
              <a:tblPr/>
              <a:tblGrid>
                <a:gridCol w="228600"/>
                <a:gridCol w="368280"/>
                <a:gridCol w="177840"/>
                <a:gridCol w="177840"/>
                <a:gridCol w="177840"/>
                <a:gridCol w="177840"/>
                <a:gridCol w="177840"/>
              </a:tblGrid>
              <a:tr h="231840"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5"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luste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31480"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u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980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20160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20016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19980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20016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20160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980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20016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20016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19980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20016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20016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980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20016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19980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20196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19980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extBox 4"/>
          <p:cNvSpPr/>
          <p:nvPr/>
        </p:nvSpPr>
        <p:spPr>
          <a:xfrm>
            <a:off x="901440" y="911160"/>
            <a:ext cx="103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1" name="Picture 2" descr="Fig_F1_revised.tif"/>
          <p:cNvPicPr/>
          <p:nvPr/>
        </p:nvPicPr>
        <p:blipFill>
          <a:blip r:embed="rId1"/>
          <a:stretch/>
        </p:blipFill>
        <p:spPr>
          <a:xfrm>
            <a:off x="0" y="1727280"/>
            <a:ext cx="6858000" cy="6437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Picture 3" descr="SHOREmap.allele_frequency_plot.SI-blue.SC-red.pdf"/>
          <p:cNvPicPr/>
          <p:nvPr/>
        </p:nvPicPr>
        <p:blipFill>
          <a:blip r:embed="rId1"/>
          <a:srcRect l="0" t="0" r="3609" b="0"/>
          <a:stretch/>
        </p:blipFill>
        <p:spPr>
          <a:xfrm>
            <a:off x="146160" y="878040"/>
            <a:ext cx="6610320" cy="5486400"/>
          </a:xfrm>
          <a:prstGeom prst="rect">
            <a:avLst/>
          </a:prstGeom>
          <a:ln w="0">
            <a:noFill/>
          </a:ln>
        </p:spPr>
      </p:pic>
      <p:sp>
        <p:nvSpPr>
          <p:cNvPr id="53" name="TextBox 4"/>
          <p:cNvSpPr/>
          <p:nvPr/>
        </p:nvSpPr>
        <p:spPr>
          <a:xfrm>
            <a:off x="245520" y="297000"/>
            <a:ext cx="103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Right Brace 15"/>
          <p:cNvSpPr/>
          <p:nvPr/>
        </p:nvSpPr>
        <p:spPr>
          <a:xfrm rot="5400000">
            <a:off x="2269080" y="5512320"/>
            <a:ext cx="104760" cy="179280"/>
          </a:xfrm>
          <a:custGeom>
            <a:avLst/>
            <a:gdLst>
              <a:gd name="textAreaLeft" fmla="*/ 0 w 104760"/>
              <a:gd name="textAreaRight" fmla="*/ 37800 w 104760"/>
              <a:gd name="textAreaTop" fmla="*/ 2520 h 179280"/>
              <a:gd name="textAreaBottom" fmla="*/ 176760 h 179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521"/>
                  <a:pt x="10800" y="1042"/>
                </a:cubicBezTo>
                <a:lnTo>
                  <a:pt x="10800" y="9758"/>
                </a:lnTo>
                <a:cubicBezTo>
                  <a:pt x="10800" y="10279"/>
                  <a:pt x="16200" y="10800"/>
                  <a:pt x="21600" y="10800"/>
                </a:cubicBezTo>
                <a:cubicBezTo>
                  <a:pt x="16200" y="10800"/>
                  <a:pt x="10800" y="11321"/>
                  <a:pt x="10800" y="11842"/>
                </a:cubicBezTo>
                <a:lnTo>
                  <a:pt x="10800" y="20558"/>
                </a:lnTo>
                <a:cubicBezTo>
                  <a:pt x="10800" y="21079"/>
                  <a:pt x="5400" y="21600"/>
                  <a:pt x="0" y="21600"/>
                </a:cubicBezTo>
              </a:path>
            </a:pathLst>
          </a:custGeom>
          <a:noFill/>
          <a:ln w="25560">
            <a:solidFill>
              <a:srgbClr val="4f81bd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6"/>
          <p:cNvSpPr/>
          <p:nvPr/>
        </p:nvSpPr>
        <p:spPr>
          <a:xfrm>
            <a:off x="2090520" y="5616720"/>
            <a:ext cx="54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S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locu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6" name="Straight Arrow Connector 17"/>
          <p:cNvCxnSpPr/>
          <p:nvPr/>
        </p:nvCxnSpPr>
        <p:spPr>
          <a:xfrm flipV="1">
            <a:off x="1557000" y="4158360"/>
            <a:ext cx="1080" cy="181800"/>
          </a:xfrm>
          <a:prstGeom prst="straightConnector1">
            <a:avLst/>
          </a:prstGeom>
          <a:ln w="25560">
            <a:solidFill>
              <a:srgbClr val="4f81bd"/>
            </a:solidFill>
            <a:miter/>
            <a:tailEnd len="med" type="arrow" w="med"/>
          </a:ln>
        </p:spPr>
      </p:cxnSp>
      <p:cxnSp>
        <p:nvCxnSpPr>
          <p:cNvPr id="57" name="Straight Arrow Connector 18"/>
          <p:cNvCxnSpPr/>
          <p:nvPr/>
        </p:nvCxnSpPr>
        <p:spPr>
          <a:xfrm flipV="1">
            <a:off x="690120" y="5517360"/>
            <a:ext cx="1080" cy="181800"/>
          </a:xfrm>
          <a:prstGeom prst="straightConnector1">
            <a:avLst/>
          </a:prstGeom>
          <a:ln w="25560">
            <a:solidFill>
              <a:srgbClr val="4f81bd"/>
            </a:solidFill>
            <a:miter/>
            <a:tailEnd len="med" type="arrow" w="med"/>
          </a:ln>
        </p:spPr>
      </p:cxnSp>
      <p:cxnSp>
        <p:nvCxnSpPr>
          <p:cNvPr id="58" name="Straight Arrow Connector 19"/>
          <p:cNvCxnSpPr/>
          <p:nvPr/>
        </p:nvCxnSpPr>
        <p:spPr>
          <a:xfrm flipV="1">
            <a:off x="874440" y="5517360"/>
            <a:ext cx="1080" cy="181800"/>
          </a:xfrm>
          <a:prstGeom prst="straightConnector1">
            <a:avLst/>
          </a:prstGeom>
          <a:ln w="25560">
            <a:solidFill>
              <a:srgbClr val="4f81bd"/>
            </a:solidFill>
            <a:miter/>
            <a:tailEnd len="med" type="arrow" w="med"/>
          </a:ln>
        </p:spPr>
      </p:cxnSp>
      <p:cxnSp>
        <p:nvCxnSpPr>
          <p:cNvPr id="59" name="Straight Arrow Connector 20"/>
          <p:cNvCxnSpPr/>
          <p:nvPr/>
        </p:nvCxnSpPr>
        <p:spPr>
          <a:xfrm flipV="1">
            <a:off x="1098360" y="5517360"/>
            <a:ext cx="1080" cy="181800"/>
          </a:xfrm>
          <a:prstGeom prst="straightConnector1">
            <a:avLst/>
          </a:prstGeom>
          <a:ln w="25560">
            <a:solidFill>
              <a:srgbClr val="4f81bd"/>
            </a:solidFill>
            <a:miter/>
            <a:tailEnd len="med" type="arrow" w="med"/>
          </a:ln>
        </p:spPr>
      </p:cxnSp>
      <p:cxnSp>
        <p:nvCxnSpPr>
          <p:cNvPr id="60" name="Straight Arrow Connector 21"/>
          <p:cNvCxnSpPr/>
          <p:nvPr/>
        </p:nvCxnSpPr>
        <p:spPr>
          <a:xfrm flipV="1">
            <a:off x="1471320" y="5517360"/>
            <a:ext cx="1080" cy="181800"/>
          </a:xfrm>
          <a:prstGeom prst="straightConnector1">
            <a:avLst/>
          </a:prstGeom>
          <a:ln w="25560">
            <a:solidFill>
              <a:srgbClr val="4f81bd"/>
            </a:solidFill>
            <a:miter/>
            <a:tailEnd len="med" type="arrow" w="med"/>
          </a:ln>
        </p:spPr>
      </p:cxnSp>
      <p:cxnSp>
        <p:nvCxnSpPr>
          <p:cNvPr id="61" name="Straight Arrow Connector 22"/>
          <p:cNvCxnSpPr/>
          <p:nvPr/>
        </p:nvCxnSpPr>
        <p:spPr>
          <a:xfrm flipV="1">
            <a:off x="1829880" y="4158360"/>
            <a:ext cx="1080" cy="181800"/>
          </a:xfrm>
          <a:prstGeom prst="straightConnector1">
            <a:avLst/>
          </a:prstGeom>
          <a:ln w="25560">
            <a:solidFill>
              <a:srgbClr val="4f81bd"/>
            </a:solidFill>
            <a:miter/>
            <a:tailEnd len="med" type="arrow" w="med"/>
          </a:ln>
        </p:spPr>
      </p:cxnSp>
      <p:cxnSp>
        <p:nvCxnSpPr>
          <p:cNvPr id="62" name="Straight Arrow Connector 23"/>
          <p:cNvCxnSpPr/>
          <p:nvPr/>
        </p:nvCxnSpPr>
        <p:spPr>
          <a:xfrm flipV="1">
            <a:off x="2329920" y="4158360"/>
            <a:ext cx="1080" cy="181800"/>
          </a:xfrm>
          <a:prstGeom prst="straightConnector1">
            <a:avLst/>
          </a:prstGeom>
          <a:ln w="25560">
            <a:solidFill>
              <a:srgbClr val="4f81bd"/>
            </a:solidFill>
            <a:miter/>
            <a:tailEnd len="med" type="arrow" w="med"/>
          </a:ln>
        </p:spPr>
      </p:cxnSp>
      <p:cxnSp>
        <p:nvCxnSpPr>
          <p:cNvPr id="63" name="Straight Arrow Connector 24"/>
          <p:cNvCxnSpPr/>
          <p:nvPr/>
        </p:nvCxnSpPr>
        <p:spPr>
          <a:xfrm flipV="1">
            <a:off x="1195200" y="4158360"/>
            <a:ext cx="1080" cy="181800"/>
          </a:xfrm>
          <a:prstGeom prst="straightConnector1">
            <a:avLst/>
          </a:prstGeom>
          <a:ln w="25560">
            <a:solidFill>
              <a:srgbClr val="4f81bd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Picture 5" descr="scaffold_7 mapping_SC_con.pdf"/>
          <p:cNvPicPr/>
          <p:nvPr/>
        </p:nvPicPr>
        <p:blipFill>
          <a:blip r:embed="rId1"/>
          <a:srcRect l="0" t="0" r="0" b="85068"/>
          <a:stretch/>
        </p:blipFill>
        <p:spPr>
          <a:xfrm>
            <a:off x="36360" y="1625760"/>
            <a:ext cx="6669360" cy="990360"/>
          </a:xfrm>
          <a:prstGeom prst="rect">
            <a:avLst/>
          </a:prstGeom>
          <a:ln w="0">
            <a:noFill/>
          </a:ln>
        </p:spPr>
      </p:pic>
      <p:sp>
        <p:nvSpPr>
          <p:cNvPr id="65" name="TextBox 6"/>
          <p:cNvSpPr/>
          <p:nvPr/>
        </p:nvSpPr>
        <p:spPr>
          <a:xfrm>
            <a:off x="1900080" y="2649600"/>
            <a:ext cx="547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B16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7"/>
          <p:cNvSpPr/>
          <p:nvPr/>
        </p:nvSpPr>
        <p:spPr>
          <a:xfrm>
            <a:off x="3051720" y="2649600"/>
            <a:ext cx="547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B12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8"/>
          <p:cNvSpPr/>
          <p:nvPr/>
        </p:nvSpPr>
        <p:spPr>
          <a:xfrm>
            <a:off x="3271680" y="2844720"/>
            <a:ext cx="564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ARK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9"/>
          <p:cNvSpPr/>
          <p:nvPr/>
        </p:nvSpPr>
        <p:spPr>
          <a:xfrm>
            <a:off x="5320800" y="2649600"/>
            <a:ext cx="457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B8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10"/>
          <p:cNvSpPr/>
          <p:nvPr/>
        </p:nvSpPr>
        <p:spPr>
          <a:xfrm>
            <a:off x="5538240" y="2844720"/>
            <a:ext cx="457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B7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11"/>
          <p:cNvSpPr/>
          <p:nvPr/>
        </p:nvSpPr>
        <p:spPr>
          <a:xfrm>
            <a:off x="260640" y="500040"/>
            <a:ext cx="103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6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2-17T18:29:40Z</dcterms:created>
  <dc:creator>Barb</dc:creator>
  <dc:description/>
  <dc:language>en-US</dc:language>
  <cp:lastModifiedBy>L.Latha</cp:lastModifiedBy>
  <cp:lastPrinted>2016-03-02T16:43:11Z</cp:lastPrinted>
  <dcterms:modified xsi:type="dcterms:W3CDTF">2016-10-31T04:09:54Z</dcterms:modified>
  <cp:revision>47</cp:revision>
  <dc:subject/>
  <dc:title>PowerPoint Presentation</dc:title>
</cp:coreProperties>
</file>